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89" r:id="rId2"/>
    <p:sldId id="258" r:id="rId3"/>
    <p:sldId id="282" r:id="rId4"/>
    <p:sldId id="288" r:id="rId5"/>
    <p:sldId id="265" r:id="rId6"/>
    <p:sldId id="296" r:id="rId7"/>
    <p:sldId id="297" r:id="rId8"/>
    <p:sldId id="290" r:id="rId9"/>
    <p:sldId id="283" r:id="rId10"/>
    <p:sldId id="284" r:id="rId11"/>
    <p:sldId id="285" r:id="rId12"/>
    <p:sldId id="28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72" autoAdjust="0"/>
    <p:restoredTop sz="96327"/>
  </p:normalViewPr>
  <p:slideViewPr>
    <p:cSldViewPr snapToGrid="0">
      <p:cViewPr varScale="1">
        <p:scale>
          <a:sx n="113" d="100"/>
          <a:sy n="113" d="100"/>
        </p:scale>
        <p:origin x="62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0DF8E3-D968-4241-A2C4-BF80190B4F7F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C1A5BD-2796-445A-A1B6-FC29A0A69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359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20F99C-9375-5A5F-B8A3-6765981098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3E9A660-BB36-B6E1-7FB2-70E2321347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FB9717-370C-33AB-19F7-ED08E306D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467C9C-BF34-AEC1-8300-3C40214E8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F1D94-D622-0462-BB36-93459B743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618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7A9A1-6571-AD1B-7087-E20A032E5C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596D1D-48E3-1CC0-7DB5-10D82694DC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5F88A-1CAB-32D8-318A-4F4C8A14F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54981-508B-9CF3-B3B1-EAA4DABE3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1C6D94-CEAF-C55A-8695-CEB751011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368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9AE53F-9FC5-E701-2793-75E9B5139C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600E28-77E5-28EC-E2E0-48D5CC9201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A6E1CB-CEAE-DB01-09E5-7E04F2AAD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8F1E4-3550-2C99-E1B2-495C544B6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C5CABC-D5C3-E124-7B63-7A202521B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700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092A4-79CC-C5AF-E51D-99C50BA3DD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C7061E-6D31-3DF7-23F2-96D8A303AF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F8A52E-8B71-1BAC-E7F7-0D27B0B25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A6F11A-09E8-CC3A-5B94-E93A617F8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AF0BE-1018-0DC8-398E-7970C47C0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53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70C8D8-004B-DB3F-6085-38EFD46EA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56D34D-9885-B00C-9DE9-D30AB0BD1A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F6B668-3A66-7647-D336-19C135055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7100F3-6E1B-5CB0-1441-05B04B4EB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D8575B-D779-4285-1FCB-932E9598E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561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E53F5-EBBD-33AA-019E-AEAD3A18D7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B182E4-2A33-7042-EBD8-23A9FFF7FF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56CF5A-6686-16F4-3606-A622BE375D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F3FD5A-E5FB-2909-9568-3B5F3A59F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77A131-27C9-4495-0717-610D82386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1BA5F6-1F46-87AD-83C6-7E2C42347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580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DB797-7FF8-ACD6-7440-20E88D336D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37827A-3F57-230A-1184-F97BE1CA4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ACCF5D-2CAB-EAC1-92D6-A692182E8C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E589CC-2CF4-B305-3943-16CEC04ED8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F8D080-67A1-EBC1-110B-124D5012FF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E2223A-6A1F-23BA-04F5-9C8FA2952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F3CCE94-58D8-3835-1AB2-1B605546D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E3727C-2D6F-7E18-1CDE-CCA180DC2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440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705CB4-75FE-567F-11BC-82D561399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47A4F3-0ADB-189E-FCF0-02B557B0F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7BC46C-F74C-51D8-3BBA-EA9ABEC16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4F9072-D74A-FFB2-F7A6-7D83EDC78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25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88DAE3-914C-F056-5881-35692C732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A76BDE-51D9-DA59-27FB-EDF6302AC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E34C37-1C0C-9125-C448-4F525B7FC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864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F720ED-DC05-73CC-D95E-0650A843C1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6129F7-4C91-97C8-A5CC-58E107452B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D78A8F-713E-0946-D6C4-8820BA921E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A69864-B678-D09E-8193-54647954D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95E297-0946-F6AA-97B9-A03F78CC2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774247-A60F-A7BC-77F4-B34F67DB7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430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689F75-C30B-25E3-1649-4A1257872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D1FA7D-91EA-D701-2943-5A49D0D0FA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998F05-CECF-7F61-F08F-C9CB8C853F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A78F29-38C4-158B-9C49-0A376A872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80A75B-8327-26CE-EB0A-13FF3EAD6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8448E1-22D7-D641-3E5C-5FAE26608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18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D4418B-E4B0-F272-79CF-326F2F8FB2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FEFA17-FCB4-606C-9FA9-A2044AB342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8677B5-7676-661C-2753-0966CE80D3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BF3DF7-501A-43FA-8FFF-8A823F3518DA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C4520C-75D4-766D-A347-41866275FF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0D99DE-C81E-8DEA-DCEA-E648F069A1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C6F2A3-D785-4C73-B410-FE2AE5876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637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7" Type="http://schemas.openxmlformats.org/officeDocument/2006/relationships/image" Target="../media/image20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18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7" Type="http://schemas.openxmlformats.org/officeDocument/2006/relationships/image" Target="../media/image25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3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7" Type="http://schemas.openxmlformats.org/officeDocument/2006/relationships/image" Target="../media/image30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2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91BCEEC-8E2B-C9C4-4484-B4A7E8576B6B}"/>
              </a:ext>
            </a:extLst>
          </p:cNvPr>
          <p:cNvGrpSpPr/>
          <p:nvPr/>
        </p:nvGrpSpPr>
        <p:grpSpPr>
          <a:xfrm>
            <a:off x="197332" y="835403"/>
            <a:ext cx="5209554" cy="2593597"/>
            <a:chOff x="5508359" y="503506"/>
            <a:chExt cx="3889238" cy="13716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54B48CE-1261-B422-76A0-90968605C0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08359" y="503506"/>
              <a:ext cx="3889238" cy="13716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629905B-2A98-BA00-6CB2-4026F4BF1E88}"/>
                </a:ext>
              </a:extLst>
            </p:cNvPr>
            <p:cNvSpPr txBox="1"/>
            <p:nvPr/>
          </p:nvSpPr>
          <p:spPr>
            <a:xfrm>
              <a:off x="7843775" y="719811"/>
              <a:ext cx="9324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ARA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F8080B70-3881-5561-99BD-1A4C21C7C74E}"/>
              </a:ext>
            </a:extLst>
          </p:cNvPr>
          <p:cNvGrpSpPr/>
          <p:nvPr/>
        </p:nvGrpSpPr>
        <p:grpSpPr>
          <a:xfrm>
            <a:off x="197327" y="3710051"/>
            <a:ext cx="5209559" cy="2593597"/>
            <a:chOff x="5528095" y="2036476"/>
            <a:chExt cx="3889241" cy="13716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B19A554-2892-9E70-64F8-EB665A6D74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28095" y="2036476"/>
              <a:ext cx="3889241" cy="13716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45A59A8-419C-9199-62C8-015EEC391884}"/>
                </a:ext>
              </a:extLst>
            </p:cNvPr>
            <p:cNvSpPr txBox="1"/>
            <p:nvPr/>
          </p:nvSpPr>
          <p:spPr>
            <a:xfrm>
              <a:off x="8024320" y="2242649"/>
              <a:ext cx="9324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EPA</a:t>
              </a:r>
              <a:endParaRPr lang="en-US" b="1" dirty="0"/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51B8090B-3596-0E94-6B87-0C8CE4983F53}"/>
              </a:ext>
            </a:extLst>
          </p:cNvPr>
          <p:cNvGrpSpPr/>
          <p:nvPr/>
        </p:nvGrpSpPr>
        <p:grpSpPr>
          <a:xfrm>
            <a:off x="5421998" y="835403"/>
            <a:ext cx="5091398" cy="2717429"/>
            <a:chOff x="5520905" y="3475750"/>
            <a:chExt cx="4093632" cy="1563208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0C9E70D-F135-BA26-7142-8D3CEB57A54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20905" y="3475750"/>
              <a:ext cx="3886200" cy="156320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D5D220D-1D7A-6E26-FF0D-CD91447B0984}"/>
                </a:ext>
              </a:extLst>
            </p:cNvPr>
            <p:cNvSpPr txBox="1"/>
            <p:nvPr/>
          </p:nvSpPr>
          <p:spPr>
            <a:xfrm>
              <a:off x="8682099" y="3789895"/>
              <a:ext cx="9324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DHA</a:t>
              </a:r>
            </a:p>
          </p:txBody>
        </p:sp>
      </p:grpSp>
      <p:pic>
        <p:nvPicPr>
          <p:cNvPr id="11" name="Picture 10" descr="A graph with lines on it&#10;&#10;Description automatically generated">
            <a:extLst>
              <a:ext uri="{FF2B5EF4-FFF2-40B4-BE49-F238E27FC236}">
                <a16:creationId xmlns:a16="http://schemas.microsoft.com/office/drawing/2014/main" id="{3A923131-2FCF-1994-A2D8-AC4F95C2D31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1998" y="3710051"/>
            <a:ext cx="6039355" cy="260173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24EA669-F057-36D8-26BA-6DF4FEC7BE0F}"/>
              </a:ext>
            </a:extLst>
          </p:cNvPr>
          <p:cNvSpPr txBox="1"/>
          <p:nvPr/>
        </p:nvSpPr>
        <p:spPr>
          <a:xfrm>
            <a:off x="10383501" y="4223303"/>
            <a:ext cx="932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-DH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ECB2215-9CA1-890C-C5C0-E4209A2A4669}"/>
              </a:ext>
            </a:extLst>
          </p:cNvPr>
          <p:cNvSpPr txBox="1"/>
          <p:nvPr/>
        </p:nvSpPr>
        <p:spPr>
          <a:xfrm>
            <a:off x="276687" y="6388200"/>
            <a:ext cx="76658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S1. 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Gas chromatograms of the oils used </a:t>
            </a:r>
            <a:r>
              <a:rPr lang="en-US" sz="12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or oral gavage.</a:t>
            </a:r>
            <a:endParaRPr 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CFB23E8-3BD9-C942-5F8E-868055193FEB}"/>
              </a:ext>
            </a:extLst>
          </p:cNvPr>
          <p:cNvSpPr txBox="1"/>
          <p:nvPr/>
        </p:nvSpPr>
        <p:spPr>
          <a:xfrm>
            <a:off x="107663" y="140880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1.</a:t>
            </a:r>
          </a:p>
        </p:txBody>
      </p:sp>
    </p:spTree>
    <p:extLst>
      <p:ext uri="{BB962C8B-B14F-4D97-AF65-F5344CB8AC3E}">
        <p14:creationId xmlns:p14="http://schemas.microsoft.com/office/powerpoint/2010/main" val="39024031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0EB717C-EF82-724C-65E3-1C4578FAB68D}"/>
              </a:ext>
            </a:extLst>
          </p:cNvPr>
          <p:cNvSpPr txBox="1"/>
          <p:nvPr/>
        </p:nvSpPr>
        <p:spPr>
          <a:xfrm>
            <a:off x="698689" y="737154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AA3241-9C2D-6710-048B-6FDC9F4C2C65}"/>
              </a:ext>
            </a:extLst>
          </p:cNvPr>
          <p:cNvSpPr txBox="1"/>
          <p:nvPr/>
        </p:nvSpPr>
        <p:spPr>
          <a:xfrm>
            <a:off x="2792994" y="737154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089D40-6FAD-FF7C-15E4-FB73453BD9F0}"/>
              </a:ext>
            </a:extLst>
          </p:cNvPr>
          <p:cNvSpPr txBox="1"/>
          <p:nvPr/>
        </p:nvSpPr>
        <p:spPr>
          <a:xfrm>
            <a:off x="5139680" y="719901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1190547-5E17-70C6-82A7-6694D7A2AC76}"/>
              </a:ext>
            </a:extLst>
          </p:cNvPr>
          <p:cNvSpPr txBox="1"/>
          <p:nvPr/>
        </p:nvSpPr>
        <p:spPr>
          <a:xfrm>
            <a:off x="2907860" y="3697870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9EC4971-9C26-AC9B-D84A-9A37260BBFD5}"/>
              </a:ext>
            </a:extLst>
          </p:cNvPr>
          <p:cNvSpPr txBox="1"/>
          <p:nvPr/>
        </p:nvSpPr>
        <p:spPr>
          <a:xfrm>
            <a:off x="5151914" y="3661014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D184728-0847-F0F3-1BB9-3160E098E6D1}"/>
              </a:ext>
            </a:extLst>
          </p:cNvPr>
          <p:cNvSpPr txBox="1"/>
          <p:nvPr/>
        </p:nvSpPr>
        <p:spPr>
          <a:xfrm>
            <a:off x="7747027" y="719901"/>
            <a:ext cx="432011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Figure S6. Expression of </a:t>
            </a:r>
            <a:r>
              <a:rPr lang="en-US" sz="12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ads2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selected tissues: a), b), c), d), and e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r graph represent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ads2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levels in </a:t>
            </a:r>
            <a:r>
              <a:rPr 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umor, Liver, and SK Mus (Skeletal Muscle) of control and gavage mice of Exp2; 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nificance was calculated using a Two-way ANOVA followed by Tukey’s multiple comparison tests; *p&lt;0.05.</a:t>
            </a:r>
            <a:endParaRPr lang="en-US" sz="1200" b="1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4B28AD0D-4ACD-3BC5-85A2-543045DECC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9370" y="652030"/>
            <a:ext cx="2328863" cy="315753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9152658-AF81-96EF-0CE6-2D09A7E1EF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37227" y="686614"/>
            <a:ext cx="2209800" cy="310038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60C5D737-1CC9-2388-3445-0CBD6FE640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72992" y="3821301"/>
            <a:ext cx="1614488" cy="300037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435C45A-748A-15E4-C6F5-9E8E20508FEE}"/>
              </a:ext>
            </a:extLst>
          </p:cNvPr>
          <p:cNvSpPr txBox="1"/>
          <p:nvPr/>
        </p:nvSpPr>
        <p:spPr>
          <a:xfrm>
            <a:off x="161026" y="217821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6.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B94B503-1C30-EB4B-D537-A5457D4E23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6747432"/>
              </p:ext>
            </p:extLst>
          </p:nvPr>
        </p:nvGraphicFramePr>
        <p:xfrm>
          <a:off x="540898" y="686614"/>
          <a:ext cx="2524125" cy="3151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524761" imgH="3151745" progId="Prism10.Document">
                  <p:embed/>
                </p:oleObj>
              </mc:Choice>
              <mc:Fallback>
                <p:oleObj name="Prism 10" r:id="rId5" imgW="2524761" imgH="315174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0898" y="686614"/>
                        <a:ext cx="2524125" cy="3151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id="{BE482DA9-B8D4-8BEF-02FA-FE93714B90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28829" y="3764815"/>
            <a:ext cx="2033588" cy="3000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60758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E0980C4-06B2-6D87-76FD-A5E7791B3550}"/>
              </a:ext>
            </a:extLst>
          </p:cNvPr>
          <p:cNvSpPr txBox="1"/>
          <p:nvPr/>
        </p:nvSpPr>
        <p:spPr>
          <a:xfrm>
            <a:off x="546339" y="696210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7245B92-5563-E4D4-7D12-28C1DF041F14}"/>
              </a:ext>
            </a:extLst>
          </p:cNvPr>
          <p:cNvSpPr txBox="1"/>
          <p:nvPr/>
        </p:nvSpPr>
        <p:spPr>
          <a:xfrm>
            <a:off x="2696665" y="696210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EE3748-E79E-383A-B69A-6A26C2FF3987}"/>
              </a:ext>
            </a:extLst>
          </p:cNvPr>
          <p:cNvSpPr txBox="1"/>
          <p:nvPr/>
        </p:nvSpPr>
        <p:spPr>
          <a:xfrm>
            <a:off x="4744849" y="696210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DD382C-6D30-D558-3D0F-76F80ED5CB6C}"/>
              </a:ext>
            </a:extLst>
          </p:cNvPr>
          <p:cNvSpPr txBox="1"/>
          <p:nvPr/>
        </p:nvSpPr>
        <p:spPr>
          <a:xfrm>
            <a:off x="2614042" y="3791732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700C726-2A2C-5CC4-B294-CAFD9A540324}"/>
              </a:ext>
            </a:extLst>
          </p:cNvPr>
          <p:cNvSpPr txBox="1"/>
          <p:nvPr/>
        </p:nvSpPr>
        <p:spPr>
          <a:xfrm>
            <a:off x="4826079" y="3791732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2DCAE67-278E-550D-F4ED-4B97A8EE4F99}"/>
              </a:ext>
            </a:extLst>
          </p:cNvPr>
          <p:cNvSpPr txBox="1"/>
          <p:nvPr/>
        </p:nvSpPr>
        <p:spPr>
          <a:xfrm>
            <a:off x="7189591" y="449845"/>
            <a:ext cx="4331612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Figure S7. Expression of </a:t>
            </a:r>
            <a:r>
              <a:rPr lang="en-US" sz="12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lovl2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selected tissues: a), b), c), d), and e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r graph represent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</a:t>
            </a:r>
            <a:r>
              <a:rPr lang="en-US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vl2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levels in </a:t>
            </a:r>
            <a:r>
              <a:rPr 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umor, Liver, and SK Mus (Skeletal Muscle) of control and gavage mice of Exp2; 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nificance was calculated using a Two-way ANOVA followed by Tukey’s multiple comparison tests; *p&lt;0.05 and **p&lt;0.01.</a:t>
            </a:r>
            <a:endParaRPr lang="en-US" sz="1200" b="1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3644AE7-7330-2024-3FF4-5F0FFF5169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6235" y="710542"/>
            <a:ext cx="2328863" cy="315753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ED69662-ED0A-7CED-B5EC-DD839DFEF8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5098" y="3820956"/>
            <a:ext cx="1614488" cy="300037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5812C17-EF00-1212-6DE9-442EAAB369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18736" y="703708"/>
            <a:ext cx="2209800" cy="315753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59D8979-741D-F742-BE3A-D2C509D68616}"/>
              </a:ext>
            </a:extLst>
          </p:cNvPr>
          <p:cNvSpPr txBox="1"/>
          <p:nvPr/>
        </p:nvSpPr>
        <p:spPr>
          <a:xfrm>
            <a:off x="161026" y="217821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7.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935F96A-E300-F00C-35D9-06B7A5F103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023927"/>
              </p:ext>
            </p:extLst>
          </p:nvPr>
        </p:nvGraphicFramePr>
        <p:xfrm>
          <a:off x="401323" y="731225"/>
          <a:ext cx="2516187" cy="3151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515404" imgH="3151745" progId="Prism10.Document">
                  <p:embed/>
                </p:oleObj>
              </mc:Choice>
              <mc:Fallback>
                <p:oleObj name="Prism 10" r:id="rId5" imgW="2515404" imgH="315174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1323" y="731225"/>
                        <a:ext cx="2516187" cy="3151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id="{DA343B56-1996-3475-02C5-BF40E4C9B70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89321" y="3903095"/>
            <a:ext cx="2033588" cy="3000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46899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0AD5440-C3B2-F349-5DB4-86B090B734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4224" y="847939"/>
            <a:ext cx="1922726" cy="27432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4EE3E6A-A628-4473-8748-80BB4FA4B4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6941" y="828087"/>
            <a:ext cx="2023265" cy="27432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D93AC07-A8A9-F13C-1AF6-815CE705A9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14224" y="3631276"/>
            <a:ext cx="1476103" cy="27432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3C8AE40-0E36-F35C-277A-B32EFB22B3E1}"/>
              </a:ext>
            </a:extLst>
          </p:cNvPr>
          <p:cNvSpPr txBox="1"/>
          <p:nvPr/>
        </p:nvSpPr>
        <p:spPr>
          <a:xfrm>
            <a:off x="546339" y="778097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53180F-07B4-61D3-57BB-04AE4806F122}"/>
              </a:ext>
            </a:extLst>
          </p:cNvPr>
          <p:cNvSpPr txBox="1"/>
          <p:nvPr/>
        </p:nvSpPr>
        <p:spPr>
          <a:xfrm>
            <a:off x="2696665" y="778097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385A93-DBB6-8C9A-453D-EF8932F6D30E}"/>
              </a:ext>
            </a:extLst>
          </p:cNvPr>
          <p:cNvSpPr txBox="1"/>
          <p:nvPr/>
        </p:nvSpPr>
        <p:spPr>
          <a:xfrm>
            <a:off x="4797767" y="778373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C809F6-4916-D164-C4CB-D6F3FF9F3D0B}"/>
              </a:ext>
            </a:extLst>
          </p:cNvPr>
          <p:cNvSpPr txBox="1"/>
          <p:nvPr/>
        </p:nvSpPr>
        <p:spPr>
          <a:xfrm>
            <a:off x="2817819" y="3581662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6BB1776-48B5-0E10-2130-F1B2C4E6C715}"/>
              </a:ext>
            </a:extLst>
          </p:cNvPr>
          <p:cNvSpPr txBox="1"/>
          <p:nvPr/>
        </p:nvSpPr>
        <p:spPr>
          <a:xfrm>
            <a:off x="4727438" y="3561434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3BF25CF-1F2E-696F-6508-F785A3DCFC92}"/>
              </a:ext>
            </a:extLst>
          </p:cNvPr>
          <p:cNvSpPr txBox="1"/>
          <p:nvPr/>
        </p:nvSpPr>
        <p:spPr>
          <a:xfrm>
            <a:off x="7176977" y="402487"/>
            <a:ext cx="4468684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Figure S8. Expression of </a:t>
            </a:r>
            <a:r>
              <a:rPr lang="en-US" sz="12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lovl5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selected tissues: a), b), c), d), and e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r graph represent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lo</a:t>
            </a:r>
            <a:r>
              <a:rPr lang="en-US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l5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levels in </a:t>
            </a:r>
            <a:r>
              <a:rPr 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umor, Liver, and SK Mus (Skeletal Muscle) of control and gavage mice of Exp2; 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nificance was calculated using a Two-way ANOVA followed by Tukey’s multiple comparison tests; *p&lt;0.05 and **p&lt;0.01.</a:t>
            </a:r>
            <a:endParaRPr lang="en-US" sz="1200" b="1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98E519-4D60-63FD-1C60-F598C0F09F66}"/>
              </a:ext>
            </a:extLst>
          </p:cNvPr>
          <p:cNvSpPr txBox="1"/>
          <p:nvPr/>
        </p:nvSpPr>
        <p:spPr>
          <a:xfrm>
            <a:off x="161026" y="217821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8.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A4D7C51-69F5-3A56-B4B8-4464DF78A7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6634298"/>
              </p:ext>
            </p:extLst>
          </p:nvPr>
        </p:nvGraphicFramePr>
        <p:xfrm>
          <a:off x="2757011" y="3674820"/>
          <a:ext cx="1857874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029526" imgH="2996227" progId="Prism10.Document">
                  <p:embed/>
                </p:oleObj>
              </mc:Choice>
              <mc:Fallback>
                <p:oleObj name="Prism 10" r:id="rId5" imgW="2029526" imgH="299622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757011" y="3674820"/>
                        <a:ext cx="1857874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Picture 14">
            <a:extLst>
              <a:ext uri="{FF2B5EF4-FFF2-40B4-BE49-F238E27FC236}">
                <a16:creationId xmlns:a16="http://schemas.microsoft.com/office/drawing/2014/main" id="{6B512734-1D62-7A6B-713F-2C76AF823D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0955" y="847939"/>
            <a:ext cx="2199969" cy="2746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30198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0B2B1BD-C6FC-99D4-6B84-AE962AEBA75E}"/>
              </a:ext>
            </a:extLst>
          </p:cNvPr>
          <p:cNvSpPr txBox="1"/>
          <p:nvPr/>
        </p:nvSpPr>
        <p:spPr>
          <a:xfrm>
            <a:off x="161026" y="217821"/>
            <a:ext cx="4882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Table S1.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34BBA52-3C84-5B37-A930-7FDA700A71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0944524"/>
              </p:ext>
            </p:extLst>
          </p:nvPr>
        </p:nvGraphicFramePr>
        <p:xfrm>
          <a:off x="4657559" y="869754"/>
          <a:ext cx="4126435" cy="5884569"/>
        </p:xfrm>
        <a:graphic>
          <a:graphicData uri="http://schemas.openxmlformats.org/drawingml/2006/table">
            <a:tbl>
              <a:tblPr firstRow="1" firstCol="1" bandRow="1"/>
              <a:tblGrid>
                <a:gridCol w="1397920">
                  <a:extLst>
                    <a:ext uri="{9D8B030D-6E8A-4147-A177-3AD203B41FA5}">
                      <a16:colId xmlns:a16="http://schemas.microsoft.com/office/drawing/2014/main" val="2959591235"/>
                    </a:ext>
                  </a:extLst>
                </a:gridCol>
                <a:gridCol w="909505">
                  <a:extLst>
                    <a:ext uri="{9D8B030D-6E8A-4147-A177-3AD203B41FA5}">
                      <a16:colId xmlns:a16="http://schemas.microsoft.com/office/drawing/2014/main" val="2324584612"/>
                    </a:ext>
                  </a:extLst>
                </a:gridCol>
                <a:gridCol w="909505">
                  <a:extLst>
                    <a:ext uri="{9D8B030D-6E8A-4147-A177-3AD203B41FA5}">
                      <a16:colId xmlns:a16="http://schemas.microsoft.com/office/drawing/2014/main" val="3853043748"/>
                    </a:ext>
                  </a:extLst>
                </a:gridCol>
                <a:gridCol w="909505">
                  <a:extLst>
                    <a:ext uri="{9D8B030D-6E8A-4147-A177-3AD203B41FA5}">
                      <a16:colId xmlns:a16="http://schemas.microsoft.com/office/drawing/2014/main" val="4116613146"/>
                    </a:ext>
                  </a:extLst>
                </a:gridCol>
              </a:tblGrid>
              <a:tr h="212102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Dosing Oil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4356" marR="4356" marT="435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3415934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r" fontAlgn="ctr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AR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EP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DH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1271832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14:0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69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13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1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4161455156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16:0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4.94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14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51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2015290033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16:0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13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05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17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1036149775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18:0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9.26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33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0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1686441321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18:1n-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1.02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31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17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511945372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18:2n-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7.2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12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0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3312541486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0:0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73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19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4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2406110850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20:0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35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73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47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95866351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20:2n-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49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17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08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3070184245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0:4n-6 (ARA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44.19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3.94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0.2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2965672805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22:0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.41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.27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5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4080159006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22:0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0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0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.0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196434152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0:5n-3 (EPA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0.17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87.64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5.65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2377011623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2:0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0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0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14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2034360812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22:4n-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32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0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3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3045081516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4:00:0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.58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0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0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3577815405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24:01:0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1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0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87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1659836786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2:5n-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0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.41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4.63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3977198217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2:6n-3 (DHA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</a:rPr>
                        <a:t>0.04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2.67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</a:rPr>
                        <a:t>82.46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/>
                </a:tc>
                <a:extLst>
                  <a:ext uri="{0D108BD9-81ED-4DB2-BD59-A6C34878D82A}">
                    <a16:rowId xmlns:a16="http://schemas.microsoft.com/office/drawing/2014/main" val="1334824070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356" marR="4356" marT="4356" marB="0" anchor="b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356" marR="4356" marT="435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356" marR="4356" marT="4356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356" marR="4356" marT="4356" marB="0" anchor="b"/>
                </a:tc>
                <a:extLst>
                  <a:ext uri="{0D108BD9-81ED-4DB2-BD59-A6C34878D82A}">
                    <a16:rowId xmlns:a16="http://schemas.microsoft.com/office/drawing/2014/main" val="1516318122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kern="0" dirty="0">
                          <a:effectLst/>
                        </a:rPr>
                        <a:t>Σω3 HUF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2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90.72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92.74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8733722"/>
                  </a:ext>
                </a:extLst>
              </a:tr>
              <a:tr h="2466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kern="0" dirty="0">
                          <a:effectLst/>
                        </a:rPr>
                        <a:t>Σω6 HUF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44.51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.94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5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56" marR="4356" marT="4356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64987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CBEA625-92D3-086C-6013-B61357A6125D}"/>
              </a:ext>
            </a:extLst>
          </p:cNvPr>
          <p:cNvSpPr txBox="1"/>
          <p:nvPr/>
        </p:nvSpPr>
        <p:spPr>
          <a:xfrm>
            <a:off x="4583129" y="356320"/>
            <a:ext cx="427529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Table S1.</a:t>
            </a:r>
            <a:r>
              <a:rPr lang="en-US" sz="1200" b="1" i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ompositional analysis of the oils used for dosing presented as a quantitative fatty acid profil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386660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AE0EA78-CEFE-82CD-83E5-CB0EF5BFCF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812499"/>
              </p:ext>
            </p:extLst>
          </p:nvPr>
        </p:nvGraphicFramePr>
        <p:xfrm>
          <a:off x="3690733" y="658087"/>
          <a:ext cx="5025546" cy="6079817"/>
        </p:xfrm>
        <a:graphic>
          <a:graphicData uri="http://schemas.openxmlformats.org/drawingml/2006/table">
            <a:tbl>
              <a:tblPr/>
              <a:tblGrid>
                <a:gridCol w="1675182">
                  <a:extLst>
                    <a:ext uri="{9D8B030D-6E8A-4147-A177-3AD203B41FA5}">
                      <a16:colId xmlns:a16="http://schemas.microsoft.com/office/drawing/2014/main" val="3797597929"/>
                    </a:ext>
                  </a:extLst>
                </a:gridCol>
                <a:gridCol w="1675182">
                  <a:extLst>
                    <a:ext uri="{9D8B030D-6E8A-4147-A177-3AD203B41FA5}">
                      <a16:colId xmlns:a16="http://schemas.microsoft.com/office/drawing/2014/main" val="2925400839"/>
                    </a:ext>
                  </a:extLst>
                </a:gridCol>
                <a:gridCol w="1675182">
                  <a:extLst>
                    <a:ext uri="{9D8B030D-6E8A-4147-A177-3AD203B41FA5}">
                      <a16:colId xmlns:a16="http://schemas.microsoft.com/office/drawing/2014/main" val="609975487"/>
                    </a:ext>
                  </a:extLst>
                </a:gridCol>
              </a:tblGrid>
              <a:tr h="146028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</a:rPr>
                        <a:t>Base Chow analysis</a:t>
                      </a:r>
                    </a:p>
                  </a:txBody>
                  <a:tcPr marL="4295" marR="4295" marT="4295" marB="0" anchor="b"/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497412336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</a:rPr>
                        <a:t>RT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</a:rPr>
                        <a:t>Area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674368330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</a:rPr>
                        <a:t>10:0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</a:rPr>
                        <a:t>No peak is detected.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</a:rPr>
                        <a:t>0.00%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365019413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</a:rPr>
                        <a:t>12:0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</a:rPr>
                        <a:t>2.178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</a:rPr>
                        <a:t>0.03%</a:t>
                      </a: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3086995360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2:1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.344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92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3683271230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4:0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.739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64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3640606464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4:1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.849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.34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05075253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6:0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32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6.39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1371993260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6:1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448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81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866490483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8:0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152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.83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4186463824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8:1n-9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344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2.65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288483385"/>
                  </a:ext>
                </a:extLst>
              </a:tr>
              <a:tr h="2791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8:1n-7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o peak is detected.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0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3554587512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8:2n-6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.767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7.95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380288010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8:3n-6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.944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3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1343612101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8:3n-3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.259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.74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101543123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0:0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.455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21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3744566394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0:1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.7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20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677462556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0:2n-6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.153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7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4075566774"/>
                  </a:ext>
                </a:extLst>
              </a:tr>
              <a:tr h="2791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0:3n-6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o peak is detected.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00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4104923852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0:4n-6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.584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13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774080718"/>
                  </a:ext>
                </a:extLst>
              </a:tr>
              <a:tr h="2791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0:3n-3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o peak is detected.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00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480331606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2:0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.833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31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561029013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2:1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.064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07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152288585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0:5n-3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.1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61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113413944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2:2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.466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16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1011820374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2:4n-6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.953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13%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009159533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4:0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8.072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26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3677016737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4:1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8.289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04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754182388"/>
                  </a:ext>
                </a:extLst>
              </a:tr>
              <a:tr h="146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2:5n-3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8.407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18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1472851086"/>
                  </a:ext>
                </a:extLst>
              </a:tr>
              <a:tr h="1506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2:6n-3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8.546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.30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2581830233"/>
                  </a:ext>
                </a:extLst>
              </a:tr>
              <a:tr h="1506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um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00.00%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95" marR="4295" marT="4295" marB="0" anchor="b"/>
                </a:tc>
                <a:extLst>
                  <a:ext uri="{0D108BD9-81ED-4DB2-BD59-A6C34878D82A}">
                    <a16:rowId xmlns:a16="http://schemas.microsoft.com/office/drawing/2014/main" val="48394890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3C34FFF6-5DDC-64CD-1483-85CBB5865AFE}"/>
              </a:ext>
            </a:extLst>
          </p:cNvPr>
          <p:cNvSpPr txBox="1"/>
          <p:nvPr/>
        </p:nvSpPr>
        <p:spPr>
          <a:xfrm>
            <a:off x="3615267" y="160955"/>
            <a:ext cx="65905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Table S2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se chow analysis showing the fatty acid composition </a:t>
            </a: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the chow diet (%w/w).</a:t>
            </a: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DCDC6E7-B1F3-49EE-1B06-4CF804BAD7C8}"/>
              </a:ext>
            </a:extLst>
          </p:cNvPr>
          <p:cNvSpPr txBox="1"/>
          <p:nvPr/>
        </p:nvSpPr>
        <p:spPr>
          <a:xfrm>
            <a:off x="161026" y="217821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Table  S2.</a:t>
            </a:r>
          </a:p>
        </p:txBody>
      </p:sp>
    </p:spTree>
    <p:extLst>
      <p:ext uri="{BB962C8B-B14F-4D97-AF65-F5344CB8AC3E}">
        <p14:creationId xmlns:p14="http://schemas.microsoft.com/office/powerpoint/2010/main" val="27918173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4CCC3B0-D96B-3364-7286-61416279D44E}"/>
              </a:ext>
            </a:extLst>
          </p:cNvPr>
          <p:cNvSpPr txBox="1"/>
          <p:nvPr/>
        </p:nvSpPr>
        <p:spPr>
          <a:xfrm>
            <a:off x="1732185" y="4711310"/>
            <a:ext cx="690343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Figure S2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Fatty acid profile of Neuro 2a cells:  a), b),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r graphs represent ARA, EPA, and DHA levels in the Neuro 2a cells expressing MYCN compared to Control. </a:t>
            </a: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6FE24F-ED08-C909-9173-0902688E189C}"/>
              </a:ext>
            </a:extLst>
          </p:cNvPr>
          <p:cNvSpPr txBox="1"/>
          <p:nvPr/>
        </p:nvSpPr>
        <p:spPr>
          <a:xfrm>
            <a:off x="1575758" y="1150189"/>
            <a:ext cx="408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0713C6-E43B-25F3-9761-0AF24C86F156}"/>
              </a:ext>
            </a:extLst>
          </p:cNvPr>
          <p:cNvSpPr txBox="1"/>
          <p:nvPr/>
        </p:nvSpPr>
        <p:spPr>
          <a:xfrm>
            <a:off x="4090434" y="1150189"/>
            <a:ext cx="408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DE80BA-908C-2678-EA41-AD89325B977C}"/>
              </a:ext>
            </a:extLst>
          </p:cNvPr>
          <p:cNvSpPr txBox="1"/>
          <p:nvPr/>
        </p:nvSpPr>
        <p:spPr>
          <a:xfrm>
            <a:off x="6483115" y="1150189"/>
            <a:ext cx="408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4A60A4F-9090-5901-BB1C-8F3B8226B6C6}"/>
              </a:ext>
            </a:extLst>
          </p:cNvPr>
          <p:cNvGrpSpPr/>
          <p:nvPr/>
        </p:nvGrpSpPr>
        <p:grpSpPr>
          <a:xfrm>
            <a:off x="1432929" y="1315693"/>
            <a:ext cx="2657505" cy="3157103"/>
            <a:chOff x="1432929" y="1315693"/>
            <a:chExt cx="2657505" cy="315710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404BA23-4657-A6E6-F1A3-E0E9A6388A6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11484" b="10929"/>
            <a:stretch/>
          </p:blipFill>
          <p:spPr>
            <a:xfrm>
              <a:off x="1432929" y="1685025"/>
              <a:ext cx="2657505" cy="278777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4DE016E-3C42-EDEC-E345-4C6F81AA8755}"/>
                </a:ext>
              </a:extLst>
            </p:cNvPr>
            <p:cNvSpPr txBox="1"/>
            <p:nvPr/>
          </p:nvSpPr>
          <p:spPr>
            <a:xfrm>
              <a:off x="2542506" y="1315693"/>
              <a:ext cx="1167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RA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32265EC2-77A5-CC73-FEED-3B09FA0C2D72}"/>
              </a:ext>
            </a:extLst>
          </p:cNvPr>
          <p:cNvGrpSpPr/>
          <p:nvPr/>
        </p:nvGrpSpPr>
        <p:grpSpPr>
          <a:xfrm>
            <a:off x="6285632" y="1315693"/>
            <a:ext cx="2800998" cy="3157104"/>
            <a:chOff x="6285632" y="1315693"/>
            <a:chExt cx="2800998" cy="3157104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396B7C1-9D8D-FE8F-DB86-D9D27CD358C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11484" b="10929"/>
            <a:stretch/>
          </p:blipFill>
          <p:spPr>
            <a:xfrm>
              <a:off x="6285632" y="1685025"/>
              <a:ext cx="2800998" cy="2787772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209CE80-D288-BC8A-E30D-31B5F897E41D}"/>
                </a:ext>
              </a:extLst>
            </p:cNvPr>
            <p:cNvSpPr txBox="1"/>
            <p:nvPr/>
          </p:nvSpPr>
          <p:spPr>
            <a:xfrm>
              <a:off x="7619071" y="1315693"/>
              <a:ext cx="8103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DHA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F6A795A2-5A80-0605-5240-77BB1A7FD139}"/>
              </a:ext>
            </a:extLst>
          </p:cNvPr>
          <p:cNvGrpSpPr/>
          <p:nvPr/>
        </p:nvGrpSpPr>
        <p:grpSpPr>
          <a:xfrm>
            <a:off x="3783403" y="1352106"/>
            <a:ext cx="2800998" cy="3120691"/>
            <a:chOff x="3783403" y="1352106"/>
            <a:chExt cx="2800998" cy="312069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8C3F16D-047A-A63C-9BBC-0B65F47ABB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11484" b="10929"/>
            <a:stretch/>
          </p:blipFill>
          <p:spPr>
            <a:xfrm>
              <a:off x="3783403" y="1685025"/>
              <a:ext cx="2800998" cy="2787772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66E3DE4-DF4D-E17C-3B3A-6D80516EBA4F}"/>
                </a:ext>
              </a:extLst>
            </p:cNvPr>
            <p:cNvSpPr txBox="1"/>
            <p:nvPr/>
          </p:nvSpPr>
          <p:spPr>
            <a:xfrm>
              <a:off x="5027476" y="1352106"/>
              <a:ext cx="1167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EPA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6A4D45C8-E564-5C1B-8626-AD27216F1633}"/>
              </a:ext>
            </a:extLst>
          </p:cNvPr>
          <p:cNvSpPr txBox="1"/>
          <p:nvPr/>
        </p:nvSpPr>
        <p:spPr>
          <a:xfrm>
            <a:off x="161026" y="217821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2.</a:t>
            </a:r>
          </a:p>
        </p:txBody>
      </p:sp>
    </p:spTree>
    <p:extLst>
      <p:ext uri="{BB962C8B-B14F-4D97-AF65-F5344CB8AC3E}">
        <p14:creationId xmlns:p14="http://schemas.microsoft.com/office/powerpoint/2010/main" val="2129732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4128208-C052-9418-E1D1-8C90291335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8229463"/>
              </p:ext>
            </p:extLst>
          </p:nvPr>
        </p:nvGraphicFramePr>
        <p:xfrm>
          <a:off x="221993" y="849498"/>
          <a:ext cx="3756064" cy="3108960"/>
        </p:xfrm>
        <a:graphic>
          <a:graphicData uri="http://schemas.openxmlformats.org/drawingml/2006/table">
            <a:tbl>
              <a:tblPr firstRow="1" bandRow="1"/>
              <a:tblGrid>
                <a:gridCol w="1359391">
                  <a:extLst>
                    <a:ext uri="{9D8B030D-6E8A-4147-A177-3AD203B41FA5}">
                      <a16:colId xmlns:a16="http://schemas.microsoft.com/office/drawing/2014/main" val="2054117559"/>
                    </a:ext>
                  </a:extLst>
                </a:gridCol>
                <a:gridCol w="798891">
                  <a:extLst>
                    <a:ext uri="{9D8B030D-6E8A-4147-A177-3AD203B41FA5}">
                      <a16:colId xmlns:a16="http://schemas.microsoft.com/office/drawing/2014/main" val="402033811"/>
                    </a:ext>
                  </a:extLst>
                </a:gridCol>
                <a:gridCol w="798891">
                  <a:extLst>
                    <a:ext uri="{9D8B030D-6E8A-4147-A177-3AD203B41FA5}">
                      <a16:colId xmlns:a16="http://schemas.microsoft.com/office/drawing/2014/main" val="510436971"/>
                    </a:ext>
                  </a:extLst>
                </a:gridCol>
                <a:gridCol w="798891">
                  <a:extLst>
                    <a:ext uri="{9D8B030D-6E8A-4147-A177-3AD203B41FA5}">
                      <a16:colId xmlns:a16="http://schemas.microsoft.com/office/drawing/2014/main" val="2164123295"/>
                    </a:ext>
                  </a:extLst>
                </a:gridCol>
              </a:tblGrid>
              <a:tr h="198962"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 2a (Experiment 1)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1022291"/>
                  </a:ext>
                </a:extLst>
              </a:tr>
              <a:tr h="52022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Length (mm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width (mm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weight (g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2701235"/>
                  </a:ext>
                </a:extLst>
              </a:tr>
              <a:tr h="274320">
                <a:tc rowSpan="5">
                  <a:txBody>
                    <a:bodyPr/>
                    <a:lstStyle/>
                    <a:p>
                      <a:pPr algn="ctr"/>
                      <a:r>
                        <a:rPr lang="en-US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6317323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11100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080851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2814817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0528304"/>
                  </a:ext>
                </a:extLst>
              </a:tr>
              <a:tr h="27432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4455192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8936876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3960536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8042713A-9BEC-27B6-68B0-617B6B37B5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2777692"/>
              </p:ext>
            </p:extLst>
          </p:nvPr>
        </p:nvGraphicFramePr>
        <p:xfrm>
          <a:off x="4321463" y="862372"/>
          <a:ext cx="3756064" cy="4206240"/>
        </p:xfrm>
        <a:graphic>
          <a:graphicData uri="http://schemas.openxmlformats.org/drawingml/2006/table">
            <a:tbl>
              <a:tblPr firstRow="1" bandRow="1"/>
              <a:tblGrid>
                <a:gridCol w="1359391">
                  <a:extLst>
                    <a:ext uri="{9D8B030D-6E8A-4147-A177-3AD203B41FA5}">
                      <a16:colId xmlns:a16="http://schemas.microsoft.com/office/drawing/2014/main" val="2054117559"/>
                    </a:ext>
                  </a:extLst>
                </a:gridCol>
                <a:gridCol w="798891">
                  <a:extLst>
                    <a:ext uri="{9D8B030D-6E8A-4147-A177-3AD203B41FA5}">
                      <a16:colId xmlns:a16="http://schemas.microsoft.com/office/drawing/2014/main" val="402033811"/>
                    </a:ext>
                  </a:extLst>
                </a:gridCol>
                <a:gridCol w="798891">
                  <a:extLst>
                    <a:ext uri="{9D8B030D-6E8A-4147-A177-3AD203B41FA5}">
                      <a16:colId xmlns:a16="http://schemas.microsoft.com/office/drawing/2014/main" val="510436971"/>
                    </a:ext>
                  </a:extLst>
                </a:gridCol>
                <a:gridCol w="798891">
                  <a:extLst>
                    <a:ext uri="{9D8B030D-6E8A-4147-A177-3AD203B41FA5}">
                      <a16:colId xmlns:a16="http://schemas.microsoft.com/office/drawing/2014/main" val="2164123295"/>
                    </a:ext>
                  </a:extLst>
                </a:gridCol>
              </a:tblGrid>
              <a:tr h="241407"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 2a (Experiment 2)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1022291"/>
                  </a:ext>
                </a:extLst>
              </a:tr>
              <a:tr h="563282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Length (mm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width (mm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weight (gm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2701235"/>
                  </a:ext>
                </a:extLst>
              </a:tr>
              <a:tr h="241407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9568226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1222861"/>
                  </a:ext>
                </a:extLst>
              </a:tr>
              <a:tr h="269063">
                <a:tc v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47217047"/>
                  </a:ext>
                </a:extLst>
              </a:tr>
              <a:tr h="241407">
                <a:tc rowSpan="6">
                  <a:txBody>
                    <a:bodyPr/>
                    <a:lstStyle/>
                    <a:p>
                      <a:pPr algn="ctr"/>
                      <a:r>
                        <a:rPr lang="en-US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achidonic acid AR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6317323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8277512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5829090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11100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080851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2814817"/>
                  </a:ext>
                </a:extLst>
              </a:tr>
              <a:tr h="241407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A+ EP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4455192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8936876"/>
                  </a:ext>
                </a:extLst>
              </a:tr>
              <a:tr h="241407">
                <a:tc vMerge="1">
                  <a:txBody>
                    <a:bodyPr/>
                    <a:lstStyle/>
                    <a:p>
                      <a:pPr algn="ctr"/>
                      <a:endParaRPr 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396053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C59F5CB-A4C4-B4F3-601F-C622E6F01BE8}"/>
              </a:ext>
            </a:extLst>
          </p:cNvPr>
          <p:cNvSpPr txBox="1"/>
          <p:nvPr/>
        </p:nvSpPr>
        <p:spPr>
          <a:xfrm>
            <a:off x="163902" y="445936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A266A3-2E25-2D79-D02B-B0C9774AE502}"/>
              </a:ext>
            </a:extLst>
          </p:cNvPr>
          <p:cNvSpPr txBox="1"/>
          <p:nvPr/>
        </p:nvSpPr>
        <p:spPr>
          <a:xfrm>
            <a:off x="4175185" y="379800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779B8D-6B2E-CD8C-8972-15A396B7C1DA}"/>
              </a:ext>
            </a:extLst>
          </p:cNvPr>
          <p:cNvSpPr txBox="1"/>
          <p:nvPr/>
        </p:nvSpPr>
        <p:spPr>
          <a:xfrm>
            <a:off x="8199628" y="445936"/>
            <a:ext cx="467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4CA2FDB-1782-E6D2-222C-F0E5F436A9EE}"/>
              </a:ext>
            </a:extLst>
          </p:cNvPr>
          <p:cNvSpPr txBox="1"/>
          <p:nvPr/>
        </p:nvSpPr>
        <p:spPr>
          <a:xfrm>
            <a:off x="10073997" y="444434"/>
            <a:ext cx="467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8158540-EB38-A4C8-F55F-DA463B313F7E}"/>
              </a:ext>
            </a:extLst>
          </p:cNvPr>
          <p:cNvSpPr txBox="1"/>
          <p:nvPr/>
        </p:nvSpPr>
        <p:spPr>
          <a:xfrm>
            <a:off x="229158" y="5392211"/>
            <a:ext cx="1174857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 Figure S3.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yngeneic cell-derived xenograft (CDX) model of </a:t>
            </a:r>
            <a:r>
              <a:rPr lang="en-US" sz="12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YCN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driven neuroblastoma: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A  EPA and ARA+ EPA were administered orally every 48 hours to the mice for seven days before cell injection. 2.5*10^6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YCN</a:t>
            </a:r>
            <a:r>
              <a:rPr lang="en-US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xpressing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euro-2a cells were injected subcutaneously into the mice. ARA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PA, and ARA+EPA feeding continued until the study endpoint in both experiment rounds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a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, b)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ummary of 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mor size and mass with ARA and EPA in Exp1 and control, ARA and ARA+EPA in Exp2, respectively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, d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ar graph depicting the change in average tumor mass across different experimental groups, showing the highest tumor volume in the ARA-treated group in both experiment rounds. Significance was calculated using a t-test; *p&lt;0.05. </a:t>
            </a: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A6691BE3-CB8F-634C-776E-9088D33D95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16609" y="559609"/>
            <a:ext cx="1957388" cy="28956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5D830A0-2269-2829-1C6B-DCC590013A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09013" y="609341"/>
            <a:ext cx="2068722" cy="305089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5AF70F4-E17D-D35F-9868-2766243A3FE8}"/>
              </a:ext>
            </a:extLst>
          </p:cNvPr>
          <p:cNvSpPr txBox="1"/>
          <p:nvPr/>
        </p:nvSpPr>
        <p:spPr>
          <a:xfrm>
            <a:off x="161026" y="217821"/>
            <a:ext cx="3948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3.</a:t>
            </a:r>
          </a:p>
        </p:txBody>
      </p:sp>
    </p:spTree>
    <p:extLst>
      <p:ext uri="{BB962C8B-B14F-4D97-AF65-F5344CB8AC3E}">
        <p14:creationId xmlns:p14="http://schemas.microsoft.com/office/powerpoint/2010/main" val="15300459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A6BE93C-C2CC-DFCE-356E-94DD5C321A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3304875"/>
              </p:ext>
            </p:extLst>
          </p:nvPr>
        </p:nvGraphicFramePr>
        <p:xfrm>
          <a:off x="628645" y="1613130"/>
          <a:ext cx="9734549" cy="232775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884959">
                  <a:extLst>
                    <a:ext uri="{9D8B030D-6E8A-4147-A177-3AD203B41FA5}">
                      <a16:colId xmlns:a16="http://schemas.microsoft.com/office/drawing/2014/main" val="1662911644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2412244066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1193026230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2849859211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3683911329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4171391061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3386277153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2171659606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3396873855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1073903526"/>
                    </a:ext>
                  </a:extLst>
                </a:gridCol>
                <a:gridCol w="884959">
                  <a:extLst>
                    <a:ext uri="{9D8B030D-6E8A-4147-A177-3AD203B41FA5}">
                      <a16:colId xmlns:a16="http://schemas.microsoft.com/office/drawing/2014/main" val="2427399972"/>
                    </a:ext>
                  </a:extLst>
                </a:gridCol>
              </a:tblGrid>
              <a:tr h="3549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gure 2 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XP 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144760842"/>
                  </a:ext>
                </a:extLst>
              </a:tr>
              <a:tr h="219196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um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.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008831679"/>
                  </a:ext>
                </a:extLst>
              </a:tr>
              <a:tr h="2191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.9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7.1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849014213"/>
                  </a:ext>
                </a:extLst>
              </a:tr>
              <a:tr h="2191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921904918"/>
                  </a:ext>
                </a:extLst>
              </a:tr>
              <a:tr h="219196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um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210821255"/>
                  </a:ext>
                </a:extLst>
              </a:tr>
              <a:tr h="2191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.9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7.1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807266913"/>
                  </a:ext>
                </a:extLst>
              </a:tr>
              <a:tr h="2191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98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716311712"/>
                  </a:ext>
                </a:extLst>
              </a:tr>
              <a:tr h="219196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um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7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010026307"/>
                  </a:ext>
                </a:extLst>
              </a:tr>
              <a:tr h="2191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.4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281855554"/>
                  </a:ext>
                </a:extLst>
              </a:tr>
              <a:tr h="21919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4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097473060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04F4D08-055C-ABBA-A25D-D6EF341AED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2040045"/>
              </p:ext>
            </p:extLst>
          </p:nvPr>
        </p:nvGraphicFramePr>
        <p:xfrm>
          <a:off x="628645" y="4080992"/>
          <a:ext cx="9734550" cy="252004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95325">
                  <a:extLst>
                    <a:ext uri="{9D8B030D-6E8A-4147-A177-3AD203B41FA5}">
                      <a16:colId xmlns:a16="http://schemas.microsoft.com/office/drawing/2014/main" val="2519626591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1962302441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22015351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3519744658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606370740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4280369561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4088119106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1772381322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995940899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1369687594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4254457081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418957013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400209941"/>
                    </a:ext>
                  </a:extLst>
                </a:gridCol>
                <a:gridCol w="695325">
                  <a:extLst>
                    <a:ext uri="{9D8B030D-6E8A-4147-A177-3AD203B41FA5}">
                      <a16:colId xmlns:a16="http://schemas.microsoft.com/office/drawing/2014/main" val="3607997432"/>
                    </a:ext>
                  </a:extLst>
                </a:gridCol>
              </a:tblGrid>
              <a:tr h="2520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gure 2 B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XP 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C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AR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EP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/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/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/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130777064"/>
                  </a:ext>
                </a:extLst>
              </a:tr>
              <a:tr h="252004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um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.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918768294"/>
                  </a:ext>
                </a:extLst>
              </a:tr>
              <a:tr h="2520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.9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7.1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.5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.9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.4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.9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.9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.3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777308993"/>
                  </a:ext>
                </a:extLst>
              </a:tr>
              <a:tr h="2520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3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.4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9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8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.6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706559314"/>
                  </a:ext>
                </a:extLst>
              </a:tr>
              <a:tr h="252004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um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0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478769529"/>
                  </a:ext>
                </a:extLst>
              </a:tr>
              <a:tr h="2520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1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611697796"/>
                  </a:ext>
                </a:extLst>
              </a:tr>
              <a:tr h="2520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1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591781465"/>
                  </a:ext>
                </a:extLst>
              </a:tr>
              <a:tr h="252004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Tum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7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485843265"/>
                  </a:ext>
                </a:extLst>
              </a:tr>
              <a:tr h="2520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.4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0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.7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.8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.7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4.68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389926685"/>
                  </a:ext>
                </a:extLst>
              </a:tr>
              <a:tr h="2520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4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2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.79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2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.3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.3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.29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67602815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425B02F-C28A-785B-F8E4-8B28E79440C7}"/>
              </a:ext>
            </a:extLst>
          </p:cNvPr>
          <p:cNvSpPr txBox="1"/>
          <p:nvPr/>
        </p:nvSpPr>
        <p:spPr>
          <a:xfrm>
            <a:off x="628645" y="712079"/>
            <a:ext cx="989010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l Table S3. Fatty Acid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filing: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A, EPA, and ARA/EPA were administered orally every 48 hours to the mice for seven days before cell injection. 2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5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10^6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YCN</a:t>
            </a:r>
            <a:r>
              <a:rPr lang="en-US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xpressing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euro-2a cells were injected subcutaneously into the mice. ARA, EPA, and ARA/EPA feeding continued until the study's endpoint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table represent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HUFA levels in </a:t>
            </a:r>
            <a:r>
              <a:rPr 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umor, Liver, and SK Mus (Skeletal Muscle) of control and gavage mice of Exp1 and Exp2, respectively.</a:t>
            </a:r>
            <a:endParaRPr lang="en-US" sz="1200" b="1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E469B3E-D488-B4C8-30EB-530E46BB171A}"/>
              </a:ext>
            </a:extLst>
          </p:cNvPr>
          <p:cNvSpPr txBox="1"/>
          <p:nvPr/>
        </p:nvSpPr>
        <p:spPr>
          <a:xfrm>
            <a:off x="0" y="4884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Table S3.</a:t>
            </a:r>
          </a:p>
        </p:txBody>
      </p:sp>
    </p:spTree>
    <p:extLst>
      <p:ext uri="{BB962C8B-B14F-4D97-AF65-F5344CB8AC3E}">
        <p14:creationId xmlns:p14="http://schemas.microsoft.com/office/powerpoint/2010/main" val="41462923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04ED41D-FF54-4DCD-E1B6-D8CD15F120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228162"/>
              </p:ext>
            </p:extLst>
          </p:nvPr>
        </p:nvGraphicFramePr>
        <p:xfrm>
          <a:off x="1712310" y="2315861"/>
          <a:ext cx="8569781" cy="2828244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779071">
                  <a:extLst>
                    <a:ext uri="{9D8B030D-6E8A-4147-A177-3AD203B41FA5}">
                      <a16:colId xmlns:a16="http://schemas.microsoft.com/office/drawing/2014/main" val="4131251567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2260701425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3887566400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3784023106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3964475985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2101905728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3838589810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890010723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2520760928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611171220"/>
                    </a:ext>
                  </a:extLst>
                </a:gridCol>
                <a:gridCol w="779071">
                  <a:extLst>
                    <a:ext uri="{9D8B030D-6E8A-4147-A177-3AD203B41FA5}">
                      <a16:colId xmlns:a16="http://schemas.microsoft.com/office/drawing/2014/main" val="1110476202"/>
                    </a:ext>
                  </a:extLst>
                </a:gridCol>
              </a:tblGrid>
              <a:tr h="3703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gure 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EXP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DH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DH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-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-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-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010912312"/>
                  </a:ext>
                </a:extLst>
              </a:tr>
              <a:tr h="30724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R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5.93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7.1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.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.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.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.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.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433917265"/>
                  </a:ext>
                </a:extLst>
              </a:tr>
              <a:tr h="307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5.9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561644596"/>
                  </a:ext>
                </a:extLst>
              </a:tr>
              <a:tr h="30724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P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008236833"/>
                  </a:ext>
                </a:extLst>
              </a:tr>
              <a:tr h="307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0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3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846609226"/>
                  </a:ext>
                </a:extLst>
              </a:tr>
              <a:tr h="30724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.4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9.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9.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9.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0.2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4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867425076"/>
                  </a:ext>
                </a:extLst>
              </a:tr>
              <a:tr h="307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4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.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.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9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.5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244655635"/>
                  </a:ext>
                </a:extLst>
              </a:tr>
              <a:tr h="30724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-DH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Liv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2.9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5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6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400096436"/>
                  </a:ext>
                </a:extLst>
              </a:tr>
              <a:tr h="3072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k M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7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4045275873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B6BBAA5-CA1D-8660-EECF-D43E5EF5949C}"/>
              </a:ext>
            </a:extLst>
          </p:cNvPr>
          <p:cNvSpPr txBox="1"/>
          <p:nvPr/>
        </p:nvSpPr>
        <p:spPr>
          <a:xfrm>
            <a:off x="1635047" y="1298396"/>
            <a:ext cx="864704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Table S4. Syngeneic cell-derived xenograft (CDX) model of </a:t>
            </a:r>
            <a:r>
              <a:rPr lang="en-US" sz="12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YCN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driven neuroblastoma: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HA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D-DHA were administered orally every 48 hours to the mice for seven days before cell injection. 2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0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10^6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YCN</a:t>
            </a:r>
            <a:r>
              <a:rPr lang="en-US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xpressing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euro-2a cells were injected subcutaneously into the mice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HA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D-DHA feeding continued until the study endpoint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table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present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RA, EPA, and DHA 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levels in</a:t>
            </a:r>
            <a:r>
              <a:rPr 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Liver and SK Mus (Skeletal Muscle) of control and gavage mice of Exp 2. </a:t>
            </a: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E7FBE12-768D-B0DB-EAE6-D9686360FB6D}"/>
              </a:ext>
            </a:extLst>
          </p:cNvPr>
          <p:cNvSpPr txBox="1"/>
          <p:nvPr/>
        </p:nvSpPr>
        <p:spPr>
          <a:xfrm>
            <a:off x="0" y="4884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Table S4.</a:t>
            </a:r>
          </a:p>
        </p:txBody>
      </p:sp>
    </p:spTree>
    <p:extLst>
      <p:ext uri="{BB962C8B-B14F-4D97-AF65-F5344CB8AC3E}">
        <p14:creationId xmlns:p14="http://schemas.microsoft.com/office/powerpoint/2010/main" val="3668963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2789762-C66C-2AEE-8225-6FD161DFE1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6158" y="1520621"/>
            <a:ext cx="4852093" cy="357580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5CAC1B5-854A-9BE4-9489-4CA45377B392}"/>
              </a:ext>
            </a:extLst>
          </p:cNvPr>
          <p:cNvSpPr txBox="1"/>
          <p:nvPr/>
        </p:nvSpPr>
        <p:spPr>
          <a:xfrm>
            <a:off x="161026" y="217821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4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C9CDF0D-2F89-EA09-C577-C0F8412175F1}"/>
              </a:ext>
            </a:extLst>
          </p:cNvPr>
          <p:cNvSpPr txBox="1"/>
          <p:nvPr/>
        </p:nvSpPr>
        <p:spPr>
          <a:xfrm>
            <a:off x="3718050" y="5181486"/>
            <a:ext cx="441079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Figure S4.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ynthesis pathways of </a:t>
            </a:r>
          </a:p>
          <a:p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Arial" panose="020B0604020202020204" pitchFamily="34" charset="0"/>
              </a:rPr>
              <a:t>ω6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Arial" panose="020B0604020202020204" pitchFamily="34" charset="0"/>
              </a:rPr>
              <a:t>ω3</a:t>
            </a:r>
            <a:r>
              <a:rPr lang="en-US" sz="1400" dirty="0">
                <a:effectLst/>
              </a:rPr>
              <a:t> HUFA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7171283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F0B4AFA-7CCC-DFA6-2B29-70541715D794}"/>
              </a:ext>
            </a:extLst>
          </p:cNvPr>
          <p:cNvSpPr txBox="1"/>
          <p:nvPr/>
        </p:nvSpPr>
        <p:spPr>
          <a:xfrm>
            <a:off x="7508867" y="584197"/>
            <a:ext cx="465308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 Figure S5. Expression of </a:t>
            </a:r>
            <a:r>
              <a:rPr lang="en-US" sz="12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ads1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selected tissues: a), b), c), d), and e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r graph represent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ads1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levels in </a:t>
            </a:r>
            <a:r>
              <a:rPr lang="en-US" sz="12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umor, Liver, and SK Mus (Skeletal Muscle) of control and gavage mice of Exp2; 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nificance was calculated using a Two-way ANOVA followed by Tukey’s multiple comparison tests; *p&lt;0.05 and **p&lt;0.01.</a:t>
            </a:r>
            <a:endParaRPr lang="en-US" sz="1200" b="1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C723D3E-FA56-3F7F-80F7-8406AA9A9C0D}"/>
              </a:ext>
            </a:extLst>
          </p:cNvPr>
          <p:cNvSpPr txBox="1"/>
          <p:nvPr/>
        </p:nvSpPr>
        <p:spPr>
          <a:xfrm>
            <a:off x="544167" y="584859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0BE242E-1902-5E0A-1136-26BF90EF325C}"/>
              </a:ext>
            </a:extLst>
          </p:cNvPr>
          <p:cNvSpPr txBox="1"/>
          <p:nvPr/>
        </p:nvSpPr>
        <p:spPr>
          <a:xfrm>
            <a:off x="2712509" y="584859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67AD23-CB2E-5D9F-7100-580004A4EE0D}"/>
              </a:ext>
            </a:extLst>
          </p:cNvPr>
          <p:cNvSpPr txBox="1"/>
          <p:nvPr/>
        </p:nvSpPr>
        <p:spPr>
          <a:xfrm>
            <a:off x="4936808" y="581507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F1F36DC-BDB0-EB79-765A-582CB2D1CBF1}"/>
              </a:ext>
            </a:extLst>
          </p:cNvPr>
          <p:cNvSpPr txBox="1"/>
          <p:nvPr/>
        </p:nvSpPr>
        <p:spPr>
          <a:xfrm>
            <a:off x="2792965" y="3639028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2A4E28B-F20A-400A-1FA4-754C0F20A82A}"/>
              </a:ext>
            </a:extLst>
          </p:cNvPr>
          <p:cNvSpPr txBox="1"/>
          <p:nvPr/>
        </p:nvSpPr>
        <p:spPr>
          <a:xfrm>
            <a:off x="4869413" y="3639028"/>
            <a:ext cx="385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FCEE0C3-639A-0B5A-25FC-2BF7E97E2B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2070" y="3732627"/>
            <a:ext cx="1766888" cy="300037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87B0A53-581B-DFA0-EB2C-1C609519AB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2070" y="560390"/>
            <a:ext cx="2328863" cy="315753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7702FBE-2689-0BA5-0124-24937A83CA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73504" y="576014"/>
            <a:ext cx="2281238" cy="31575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3A0C33E-4EAF-4367-C642-9CCF1D10C8FB}"/>
              </a:ext>
            </a:extLst>
          </p:cNvPr>
          <p:cNvSpPr txBox="1"/>
          <p:nvPr/>
        </p:nvSpPr>
        <p:spPr>
          <a:xfrm>
            <a:off x="161026" y="217821"/>
            <a:ext cx="3663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Supplemental Figure S5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4067EDF-981A-E854-0591-6D4A9AEB02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802" y="576014"/>
            <a:ext cx="2519363" cy="315753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6EC475E-2B88-061B-246D-17154A5CA57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70495" y="3732627"/>
            <a:ext cx="2033588" cy="3000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0576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60</TotalTime>
  <Words>1577</Words>
  <Application>Microsoft Office PowerPoint</Application>
  <PresentationFormat>Widescreen</PresentationFormat>
  <Paragraphs>646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20" baseType="lpstr">
      <vt:lpstr>Aptos</vt:lpstr>
      <vt:lpstr>Aptos Display</vt:lpstr>
      <vt:lpstr>Aptos Narrow</vt:lpstr>
      <vt:lpstr>Arial</vt:lpstr>
      <vt:lpstr>Palatino Linotype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shwa Patel</dc:creator>
  <cp:lastModifiedBy>MDPI</cp:lastModifiedBy>
  <cp:revision>134</cp:revision>
  <dcterms:created xsi:type="dcterms:W3CDTF">2024-06-19T22:07:22Z</dcterms:created>
  <dcterms:modified xsi:type="dcterms:W3CDTF">2025-01-23T02:17:19Z</dcterms:modified>
</cp:coreProperties>
</file>